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  <p:sldId id="261" r:id="rId6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617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815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602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760442" y="365125"/>
            <a:ext cx="173484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53344" y="365125"/>
            <a:ext cx="5083274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5078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611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9396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53343" y="1825625"/>
            <a:ext cx="3409057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086226" y="1825625"/>
            <a:ext cx="3409057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6131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4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947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317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842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331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F3F27-E74A-4F7D-A1F5-07FB97DFCC83}" type="datetimeFigureOut">
              <a:rPr kumimoji="1" lang="ja-JP" altLang="en-US" smtClean="0"/>
              <a:t>2018/2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1F51D-8C3A-4CCD-A263-0CBF7BDF54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024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146059" y="742858"/>
            <a:ext cx="72373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operative characteristics of the continent and incontinent patients at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month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839901"/>
              </p:ext>
            </p:extLst>
          </p:nvPr>
        </p:nvGraphicFramePr>
        <p:xfrm>
          <a:off x="1630906" y="1280747"/>
          <a:ext cx="6644189" cy="429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47093"/>
                <a:gridCol w="1558561"/>
                <a:gridCol w="1558561"/>
                <a:gridCol w="1179974"/>
              </a:tblGrid>
              <a:tr h="424557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1, 25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52, 75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5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6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0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24557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dure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35</a:t>
                      </a:r>
                    </a:p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16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64</a:t>
                      </a:r>
                    </a:p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88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0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kumimoji="1" lang="en-US" altLang="ja-JP" sz="12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kumimoji="1" lang="ja-JP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2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/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5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606510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’Amico risk criteria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14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26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1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6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82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rve-sparin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4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(3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1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ve ti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0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d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 loss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6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.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7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tat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olume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2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section margin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7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28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0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stomosis leakag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8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(8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06</a:t>
                      </a: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PS ratio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 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0196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7492884"/>
              </p:ext>
            </p:extLst>
          </p:nvPr>
        </p:nvGraphicFramePr>
        <p:xfrm>
          <a:off x="1630906" y="1280747"/>
          <a:ext cx="6644189" cy="429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47093"/>
                <a:gridCol w="1558561"/>
                <a:gridCol w="1558561"/>
                <a:gridCol w="1179974"/>
              </a:tblGrid>
              <a:tr h="424557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07, 53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95, 47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1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3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6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24557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dur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54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5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45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5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0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kumimoji="1" lang="en-US" altLang="ja-JP" sz="12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kumimoji="1" lang="ja-JP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70</a:t>
                      </a: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/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9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606510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’Amico risk criteria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19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57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3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1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50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6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rve-sparin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 (44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(3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3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ve ti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5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8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1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d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 loss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1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1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6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tate volu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2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section margin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27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28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45</a:t>
                      </a: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stomosis leakag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1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PS ratio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6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146059" y="742858"/>
            <a:ext cx="73142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operative characteristics of the continent and incontinent patients at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onth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4715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6758774"/>
              </p:ext>
            </p:extLst>
          </p:nvPr>
        </p:nvGraphicFramePr>
        <p:xfrm>
          <a:off x="1630906" y="1280747"/>
          <a:ext cx="6644189" cy="429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47093"/>
                <a:gridCol w="1558561"/>
                <a:gridCol w="1558561"/>
                <a:gridCol w="1179974"/>
              </a:tblGrid>
              <a:tr h="424557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30, 68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0, 32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1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kumimoji="1" lang="en-US" altLang="ja-JP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5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3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1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24557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dur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66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9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30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3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1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kumimoji="1" lang="en-US" altLang="ja-JP" sz="12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kumimoji="1" lang="ja-JP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4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/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5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606510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’Amico risk criteria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6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62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4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13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36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1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rve-sparin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 (44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 (38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4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ve ti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.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1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d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 loss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1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.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3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tate volu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4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section margin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 (2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23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6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stomosis leakag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6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2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0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PS ratio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146059" y="742858"/>
            <a:ext cx="73142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operative characteristics of the continent and incontinent patients at 6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h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113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1650535"/>
              </p:ext>
            </p:extLst>
          </p:nvPr>
        </p:nvGraphicFramePr>
        <p:xfrm>
          <a:off x="1630906" y="1280747"/>
          <a:ext cx="6644189" cy="42976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47093"/>
                <a:gridCol w="1558561"/>
                <a:gridCol w="1558561"/>
                <a:gridCol w="1179974"/>
              </a:tblGrid>
              <a:tr h="424557">
                <a:tc>
                  <a:txBody>
                    <a:bodyPr/>
                    <a:lstStyle/>
                    <a:p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39, 81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ontinent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32, 19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aseline="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12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424557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dur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79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6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15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1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7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kumimoji="1" lang="en-US" altLang="ja-JP" sz="12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kumimoji="1" lang="ja-JP" alt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4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/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07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606510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’Amico risk criteria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32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63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4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5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21</a:t>
                      </a:r>
                    </a:p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1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rve-sparin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 (44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34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59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ve ti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.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4.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5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d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 loss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7.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1.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44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tate volume</a:t>
                      </a:r>
                      <a:r>
                        <a:rPr kumimoji="1" lang="en-US" altLang="ja-JP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L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2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58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section margin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 (29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31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50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stomosis leakage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7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16 %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85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42604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PS ratio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3</a:t>
                      </a:r>
                      <a:endParaRPr kumimoji="1" lang="ja-JP" altLang="en-US" sz="12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1146059" y="742858"/>
            <a:ext cx="7399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4. 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rioperative characteristics of the continent and incontinent patients at 12</a:t>
            </a:r>
            <a:r>
              <a:rPr lang="ja-JP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h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0615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16955" y="742858"/>
            <a:ext cx="7872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perioperative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inical factors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tween the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w- and high-BNPS ratio group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/>
          </p:nvPr>
        </p:nvGraphicFramePr>
        <p:xfrm>
          <a:off x="1104900" y="1280746"/>
          <a:ext cx="7734301" cy="435805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14550"/>
                <a:gridCol w="2271713"/>
                <a:gridCol w="2271713"/>
                <a:gridCol w="1076325"/>
              </a:tblGrid>
              <a:tr h="495233">
                <a:tc>
                  <a:txBody>
                    <a:bodyPr/>
                    <a:lstStyle/>
                    <a:p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BNPS ratio (&gt;</a:t>
                      </a:r>
                      <a:r>
                        <a:rPr kumimoji="1" lang="en-US" altLang="ja-JP" sz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)</a:t>
                      </a:r>
                      <a:endParaRPr kumimoji="1" lang="en-US" altLang="ja-JP" sz="12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</a:t>
                      </a:r>
                      <a:r>
                        <a:rPr kumimoji="1" lang="en-US" altLang="ja-JP" sz="12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01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BNPS ratio (</a:t>
                      </a:r>
                      <a:r>
                        <a:rPr kumimoji="1" lang="ja-JP" altLang="en-US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≤</a:t>
                      </a:r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)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2)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0" baseline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r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8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495233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edur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45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5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 54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LP 4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1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kumimoji="1" lang="en-US" altLang="ja-JP" sz="1200" b="0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kumimoji="1" lang="ja-JP" altLang="en-US" sz="1200" b="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1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A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/mL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693327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’Amico risk criteria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0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51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20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57</a:t>
                      </a:r>
                    </a:p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6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rve-sparing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 (38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 (46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rative tim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.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8.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1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d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ood loss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.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.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28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tat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olume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mL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2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resection margi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 (27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28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6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</a:tr>
              <a:tr h="297140"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astomosis leakag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 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3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33836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</TotalTime>
  <Words>705</Words>
  <Application>Microsoft Office PowerPoint</Application>
  <PresentationFormat>A4 210 x 297 mm</PresentationFormat>
  <Paragraphs>296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KAGEYAMA</dc:creator>
  <cp:lastModifiedBy>S KAGEYAMA</cp:lastModifiedBy>
  <cp:revision>20</cp:revision>
  <dcterms:created xsi:type="dcterms:W3CDTF">2016-06-17T08:12:35Z</dcterms:created>
  <dcterms:modified xsi:type="dcterms:W3CDTF">2018-02-01T12:45:07Z</dcterms:modified>
</cp:coreProperties>
</file>